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13C6B-1451-4812-A0A2-E335C89130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D6670-E997-4804-A4EA-A381ACC69B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4F297-7B97-4848-AFF5-D24408F024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37FC8-7666-43B9-AC46-3E007332AE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86B8A-7FCD-4EF1-8AC7-59173E1B05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3B5B4-77F3-40DA-8D69-A2B358F555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CC0BD-6B83-402E-9C61-6552A00C64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30DF5-7009-462A-BA81-A377B0EB50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46BA4-FCEB-4B0E-9A7A-F4A00013A3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63F1F-00AF-4F48-889C-BE745B857F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B980B-910C-4601-A4A2-5E8D8FE326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90310-5D26-419B-8D1F-40B3B8F1ED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B17662-6C12-4179-92BD-19454E4102A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"/>
          <p:cNvSpPr/>
          <p:nvPr/>
        </p:nvSpPr>
        <p:spPr>
          <a:xfrm>
            <a:off x="2061360" y="195120"/>
            <a:ext cx="443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2. Kashiwagi S. et al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71"/>
          <p:cNvSpPr/>
          <p:nvPr/>
        </p:nvSpPr>
        <p:spPr>
          <a:xfrm>
            <a:off x="555480" y="1074600"/>
            <a:ext cx="17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ge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n=59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73"/>
          <p:cNvSpPr/>
          <p:nvPr/>
        </p:nvSpPr>
        <p:spPr>
          <a:xfrm>
            <a:off x="541440" y="4037040"/>
            <a:ext cx="182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ge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I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n=2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4"/>
          <p:cNvSpPr/>
          <p:nvPr/>
        </p:nvSpPr>
        <p:spPr>
          <a:xfrm>
            <a:off x="200160" y="1116000"/>
            <a:ext cx="4363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4"/>
          <p:cNvSpPr/>
          <p:nvPr/>
        </p:nvSpPr>
        <p:spPr>
          <a:xfrm>
            <a:off x="276120" y="4081320"/>
            <a:ext cx="4003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04"/>
          <p:cNvSpPr/>
          <p:nvPr/>
        </p:nvSpPr>
        <p:spPr>
          <a:xfrm>
            <a:off x="1515600" y="1468440"/>
            <a:ext cx="1227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-cadher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1469880" y="3784680"/>
            <a:ext cx="1343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309384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276660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0"/>
          <p:cNvSpPr/>
          <p:nvPr/>
        </p:nvSpPr>
        <p:spPr>
          <a:xfrm>
            <a:off x="243324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"/>
          <p:cNvSpPr/>
          <p:nvPr/>
        </p:nvSpPr>
        <p:spPr>
          <a:xfrm>
            <a:off x="210456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2"/>
          <p:cNvSpPr/>
          <p:nvPr/>
        </p:nvSpPr>
        <p:spPr>
          <a:xfrm>
            <a:off x="177588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"/>
          <p:cNvSpPr/>
          <p:nvPr/>
        </p:nvSpPr>
        <p:spPr>
          <a:xfrm>
            <a:off x="144432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1056960" y="36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 rot="16200000">
            <a:off x="84240" y="2763720"/>
            <a:ext cx="1558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6"/>
          <p:cNvSpPr/>
          <p:nvPr/>
        </p:nvSpPr>
        <p:spPr>
          <a:xfrm>
            <a:off x="931320" y="19382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7"/>
          <p:cNvSpPr/>
          <p:nvPr/>
        </p:nvSpPr>
        <p:spPr>
          <a:xfrm>
            <a:off x="971280" y="22525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8"/>
          <p:cNvSpPr/>
          <p:nvPr/>
        </p:nvSpPr>
        <p:spPr>
          <a:xfrm>
            <a:off x="971280" y="25653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9"/>
          <p:cNvSpPr/>
          <p:nvPr/>
        </p:nvSpPr>
        <p:spPr>
          <a:xfrm>
            <a:off x="971280" y="28843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0"/>
          <p:cNvSpPr/>
          <p:nvPr/>
        </p:nvSpPr>
        <p:spPr>
          <a:xfrm>
            <a:off x="971280" y="31957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29"/>
          <p:cNvSpPr/>
          <p:nvPr/>
        </p:nvSpPr>
        <p:spPr>
          <a:xfrm>
            <a:off x="1139760" y="3581280"/>
            <a:ext cx="1976400" cy="11160"/>
          </a:xfrm>
          <a:custGeom>
            <a:avLst/>
            <a:gdLst>
              <a:gd name="textAreaLeft" fmla="*/ 0 w 1976400"/>
              <a:gd name="textAreaRight" fmla="*/ 1976760 w 197640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356" h="2">
                <a:moveTo>
                  <a:pt x="356" y="0"/>
                </a:moveTo>
                <a:lnTo>
                  <a:pt x="356" y="2"/>
                </a:lnTo>
                <a:moveTo>
                  <a:pt x="297" y="0"/>
                </a:moveTo>
                <a:lnTo>
                  <a:pt x="297" y="2"/>
                </a:lnTo>
                <a:moveTo>
                  <a:pt x="237" y="0"/>
                </a:moveTo>
                <a:lnTo>
                  <a:pt x="237" y="2"/>
                </a:lnTo>
                <a:moveTo>
                  <a:pt x="178" y="0"/>
                </a:moveTo>
                <a:lnTo>
                  <a:pt x="178" y="2"/>
                </a:lnTo>
                <a:moveTo>
                  <a:pt x="119" y="0"/>
                </a:moveTo>
                <a:lnTo>
                  <a:pt x="119" y="2"/>
                </a:lnTo>
                <a:moveTo>
                  <a:pt x="59" y="0"/>
                </a:moveTo>
                <a:lnTo>
                  <a:pt x="59" y="2"/>
                </a:lnTo>
                <a:moveTo>
                  <a:pt x="0" y="0"/>
                </a:moveTo>
                <a:lnTo>
                  <a:pt x="0" y="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30"/>
          <p:cNvSpPr/>
          <p:nvPr/>
        </p:nvSpPr>
        <p:spPr>
          <a:xfrm>
            <a:off x="1120680" y="2004840"/>
            <a:ext cx="19080" cy="1571760"/>
          </a:xfrm>
          <a:custGeom>
            <a:avLst/>
            <a:gdLst>
              <a:gd name="textAreaLeft" fmla="*/ 0 w 19080"/>
              <a:gd name="textAreaRight" fmla="*/ 19440 w 19080"/>
              <a:gd name="textAreaTop" fmla="*/ 0 h 1571760"/>
              <a:gd name="textAreaBottom" fmla="*/ 1572120 h 1571760"/>
            </a:gdLst>
            <a:ahLst/>
            <a:rect l="textAreaLeft" t="textAreaTop" r="textAreaRight" b="textAreaBottom"/>
            <a:pathLst>
              <a:path w="3" h="296">
                <a:moveTo>
                  <a:pt x="0" y="0"/>
                </a:moveTo>
                <a:lnTo>
                  <a:pt x="3" y="0"/>
                </a:lnTo>
                <a:moveTo>
                  <a:pt x="0" y="59"/>
                </a:moveTo>
                <a:lnTo>
                  <a:pt x="3" y="59"/>
                </a:lnTo>
                <a:moveTo>
                  <a:pt x="0" y="118"/>
                </a:moveTo>
                <a:lnTo>
                  <a:pt x="3" y="118"/>
                </a:lnTo>
                <a:moveTo>
                  <a:pt x="0" y="178"/>
                </a:moveTo>
                <a:lnTo>
                  <a:pt x="3" y="178"/>
                </a:lnTo>
                <a:moveTo>
                  <a:pt x="0" y="237"/>
                </a:moveTo>
                <a:lnTo>
                  <a:pt x="3" y="237"/>
                </a:lnTo>
                <a:moveTo>
                  <a:pt x="0" y="296"/>
                </a:moveTo>
                <a:lnTo>
                  <a:pt x="3" y="296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31"/>
          <p:cNvSpPr/>
          <p:nvPr/>
        </p:nvSpPr>
        <p:spPr>
          <a:xfrm>
            <a:off x="1216080" y="2004840"/>
            <a:ext cx="1711440" cy="196920"/>
          </a:xfrm>
          <a:custGeom>
            <a:avLst/>
            <a:gdLst>
              <a:gd name="textAreaLeft" fmla="*/ 0 w 1711440"/>
              <a:gd name="textAreaRight" fmla="*/ 1711800 w 1711440"/>
              <a:gd name="textAreaTop" fmla="*/ 0 h 196920"/>
              <a:gd name="textAreaBottom" fmla="*/ 197280 h 196920"/>
            </a:gdLst>
            <a:ahLst/>
            <a:rect l="textAreaLeft" t="textAreaTop" r="textAreaRight" b="textAreaBottom"/>
            <a:pathLst>
              <a:path w="308" h="37">
                <a:moveTo>
                  <a:pt x="201" y="37"/>
                </a:moveTo>
                <a:lnTo>
                  <a:pt x="308" y="37"/>
                </a:lnTo>
                <a:moveTo>
                  <a:pt x="201" y="0"/>
                </a:moveTo>
                <a:lnTo>
                  <a:pt x="201" y="37"/>
                </a:lnTo>
                <a:moveTo>
                  <a:pt x="0" y="0"/>
                </a:moveTo>
                <a:lnTo>
                  <a:pt x="201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32"/>
          <p:cNvSpPr/>
          <p:nvPr/>
        </p:nvSpPr>
        <p:spPr>
          <a:xfrm>
            <a:off x="1216080" y="2004840"/>
            <a:ext cx="1711440" cy="392400"/>
          </a:xfrm>
          <a:custGeom>
            <a:avLst/>
            <a:gdLst>
              <a:gd name="textAreaLeft" fmla="*/ 0 w 1711440"/>
              <a:gd name="textAreaRight" fmla="*/ 1711800 w 1711440"/>
              <a:gd name="textAreaTop" fmla="*/ 0 h 392400"/>
              <a:gd name="textAreaBottom" fmla="*/ 392760 h 392400"/>
            </a:gdLst>
            <a:ahLst/>
            <a:rect l="textAreaLeft" t="textAreaTop" r="textAreaRight" b="textAreaBottom"/>
            <a:pathLst>
              <a:path w="308" h="74">
                <a:moveTo>
                  <a:pt x="250" y="74"/>
                </a:moveTo>
                <a:lnTo>
                  <a:pt x="308" y="74"/>
                </a:lnTo>
                <a:moveTo>
                  <a:pt x="250" y="37"/>
                </a:moveTo>
                <a:lnTo>
                  <a:pt x="250" y="74"/>
                </a:lnTo>
                <a:moveTo>
                  <a:pt x="103" y="37"/>
                </a:moveTo>
                <a:lnTo>
                  <a:pt x="250" y="37"/>
                </a:lnTo>
                <a:moveTo>
                  <a:pt x="103" y="26"/>
                </a:moveTo>
                <a:lnTo>
                  <a:pt x="103" y="37"/>
                </a:lnTo>
                <a:moveTo>
                  <a:pt x="94" y="26"/>
                </a:moveTo>
                <a:lnTo>
                  <a:pt x="103" y="26"/>
                </a:lnTo>
                <a:moveTo>
                  <a:pt x="94" y="15"/>
                </a:moveTo>
                <a:lnTo>
                  <a:pt x="94" y="26"/>
                </a:lnTo>
                <a:moveTo>
                  <a:pt x="34" y="15"/>
                </a:moveTo>
                <a:lnTo>
                  <a:pt x="94" y="15"/>
                </a:lnTo>
                <a:moveTo>
                  <a:pt x="34" y="8"/>
                </a:moveTo>
                <a:lnTo>
                  <a:pt x="34" y="15"/>
                </a:lnTo>
                <a:moveTo>
                  <a:pt x="0" y="8"/>
                </a:moveTo>
                <a:lnTo>
                  <a:pt x="34" y="8"/>
                </a:lnTo>
                <a:moveTo>
                  <a:pt x="0" y="0"/>
                </a:moveTo>
                <a:lnTo>
                  <a:pt x="0" y="8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5"/>
          <p:cNvSpPr/>
          <p:nvPr/>
        </p:nvSpPr>
        <p:spPr>
          <a:xfrm>
            <a:off x="1139760" y="3576600"/>
            <a:ext cx="197640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6"/>
          <p:cNvSpPr/>
          <p:nvPr/>
        </p:nvSpPr>
        <p:spPr>
          <a:xfrm flipV="1">
            <a:off x="1139760" y="2004840"/>
            <a:ext cx="4680" cy="157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604"/>
          <p:cNvSpPr/>
          <p:nvPr/>
        </p:nvSpPr>
        <p:spPr>
          <a:xfrm>
            <a:off x="1276200" y="2395440"/>
            <a:ext cx="15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-) (n=3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正方形/長方形 606"/>
          <p:cNvSpPr/>
          <p:nvPr/>
        </p:nvSpPr>
        <p:spPr>
          <a:xfrm>
            <a:off x="1246320" y="1770120"/>
            <a:ext cx="181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+) (n=2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正方形/長方形 608"/>
          <p:cNvSpPr/>
          <p:nvPr/>
        </p:nvSpPr>
        <p:spPr>
          <a:xfrm>
            <a:off x="1425960" y="219564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24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81"/>
          <p:cNvSpPr/>
          <p:nvPr/>
        </p:nvSpPr>
        <p:spPr>
          <a:xfrm>
            <a:off x="1628640" y="6497640"/>
            <a:ext cx="1151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82"/>
          <p:cNvSpPr/>
          <p:nvPr/>
        </p:nvSpPr>
        <p:spPr>
          <a:xfrm>
            <a:off x="315864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83"/>
          <p:cNvSpPr/>
          <p:nvPr/>
        </p:nvSpPr>
        <p:spPr>
          <a:xfrm>
            <a:off x="283032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84"/>
          <p:cNvSpPr/>
          <p:nvPr/>
        </p:nvSpPr>
        <p:spPr>
          <a:xfrm>
            <a:off x="250308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85"/>
          <p:cNvSpPr/>
          <p:nvPr/>
        </p:nvSpPr>
        <p:spPr>
          <a:xfrm>
            <a:off x="217620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86"/>
          <p:cNvSpPr/>
          <p:nvPr/>
        </p:nvSpPr>
        <p:spPr>
          <a:xfrm>
            <a:off x="185076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87"/>
          <p:cNvSpPr/>
          <p:nvPr/>
        </p:nvSpPr>
        <p:spPr>
          <a:xfrm>
            <a:off x="152352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88"/>
          <p:cNvSpPr/>
          <p:nvPr/>
        </p:nvSpPr>
        <p:spPr>
          <a:xfrm>
            <a:off x="1131480" y="63342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89"/>
          <p:cNvSpPr/>
          <p:nvPr/>
        </p:nvSpPr>
        <p:spPr>
          <a:xfrm rot="16200000">
            <a:off x="358200" y="547848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90"/>
          <p:cNvSpPr/>
          <p:nvPr/>
        </p:nvSpPr>
        <p:spPr>
          <a:xfrm>
            <a:off x="1007280" y="47242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91"/>
          <p:cNvSpPr/>
          <p:nvPr/>
        </p:nvSpPr>
        <p:spPr>
          <a:xfrm>
            <a:off x="1083960" y="50371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92"/>
          <p:cNvSpPr/>
          <p:nvPr/>
        </p:nvSpPr>
        <p:spPr>
          <a:xfrm>
            <a:off x="1083960" y="531828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93"/>
          <p:cNvSpPr/>
          <p:nvPr/>
        </p:nvSpPr>
        <p:spPr>
          <a:xfrm>
            <a:off x="1083960" y="56246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94"/>
          <p:cNvSpPr/>
          <p:nvPr/>
        </p:nvSpPr>
        <p:spPr>
          <a:xfrm>
            <a:off x="1083960" y="590400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104"/>
          <p:cNvSpPr/>
          <p:nvPr/>
        </p:nvSpPr>
        <p:spPr>
          <a:xfrm>
            <a:off x="1220760" y="6305400"/>
            <a:ext cx="1959120" cy="9720"/>
          </a:xfrm>
          <a:custGeom>
            <a:avLst/>
            <a:gdLst>
              <a:gd name="textAreaLeft" fmla="*/ 0 w 1959120"/>
              <a:gd name="textAreaRight" fmla="*/ 1959480 w 195912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2016" h="12">
                <a:moveTo>
                  <a:pt x="2016" y="0"/>
                </a:moveTo>
                <a:lnTo>
                  <a:pt x="2016" y="12"/>
                </a:lnTo>
                <a:moveTo>
                  <a:pt x="1680" y="0"/>
                </a:moveTo>
                <a:lnTo>
                  <a:pt x="1680" y="12"/>
                </a:lnTo>
                <a:moveTo>
                  <a:pt x="1344" y="0"/>
                </a:moveTo>
                <a:lnTo>
                  <a:pt x="1344" y="12"/>
                </a:lnTo>
                <a:moveTo>
                  <a:pt x="1008" y="0"/>
                </a:moveTo>
                <a:lnTo>
                  <a:pt x="1008" y="12"/>
                </a:lnTo>
                <a:moveTo>
                  <a:pt x="672" y="0"/>
                </a:moveTo>
                <a:lnTo>
                  <a:pt x="672" y="12"/>
                </a:lnTo>
                <a:moveTo>
                  <a:pt x="336" y="0"/>
                </a:moveTo>
                <a:lnTo>
                  <a:pt x="336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105"/>
          <p:cNvSpPr/>
          <p:nvPr/>
        </p:nvSpPr>
        <p:spPr>
          <a:xfrm>
            <a:off x="1203480" y="4797360"/>
            <a:ext cx="17280" cy="1501920"/>
          </a:xfrm>
          <a:custGeom>
            <a:avLst/>
            <a:gdLst>
              <a:gd name="textAreaLeft" fmla="*/ 0 w 17280"/>
              <a:gd name="textAreaRight" fmla="*/ 17640 w 17280"/>
              <a:gd name="textAreaTop" fmla="*/ 0 h 1501920"/>
              <a:gd name="textAreaBottom" fmla="*/ 1502280 h 150192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106"/>
          <p:cNvSpPr/>
          <p:nvPr/>
        </p:nvSpPr>
        <p:spPr>
          <a:xfrm>
            <a:off x="1270080" y="4797360"/>
            <a:ext cx="1854000" cy="716040"/>
          </a:xfrm>
          <a:custGeom>
            <a:avLst/>
            <a:gdLst>
              <a:gd name="textAreaLeft" fmla="*/ 0 w 1854000"/>
              <a:gd name="textAreaRight" fmla="*/ 1854360 w 1854000"/>
              <a:gd name="textAreaTop" fmla="*/ 0 h 716040"/>
              <a:gd name="textAreaBottom" fmla="*/ 716400 h 716040"/>
            </a:gdLst>
            <a:ahLst/>
            <a:rect l="textAreaLeft" t="textAreaTop" r="textAreaRight" b="textAreaBottom"/>
            <a:pathLst>
              <a:path w="1908" h="847">
                <a:moveTo>
                  <a:pt x="1908" y="847"/>
                </a:moveTo>
                <a:lnTo>
                  <a:pt x="1908" y="847"/>
                </a:lnTo>
                <a:moveTo>
                  <a:pt x="1260" y="847"/>
                </a:moveTo>
                <a:lnTo>
                  <a:pt x="1908" y="847"/>
                </a:lnTo>
                <a:moveTo>
                  <a:pt x="1260" y="378"/>
                </a:moveTo>
                <a:lnTo>
                  <a:pt x="1260" y="847"/>
                </a:lnTo>
                <a:moveTo>
                  <a:pt x="114" y="378"/>
                </a:moveTo>
                <a:lnTo>
                  <a:pt x="1260" y="378"/>
                </a:lnTo>
                <a:moveTo>
                  <a:pt x="114" y="180"/>
                </a:moveTo>
                <a:lnTo>
                  <a:pt x="114" y="378"/>
                </a:lnTo>
                <a:moveTo>
                  <a:pt x="0" y="180"/>
                </a:moveTo>
                <a:lnTo>
                  <a:pt x="114" y="180"/>
                </a:lnTo>
                <a:moveTo>
                  <a:pt x="0" y="0"/>
                </a:moveTo>
                <a:lnTo>
                  <a:pt x="0" y="180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107"/>
          <p:cNvSpPr/>
          <p:nvPr/>
        </p:nvSpPr>
        <p:spPr>
          <a:xfrm>
            <a:off x="1270080" y="4797360"/>
            <a:ext cx="1666800" cy="1501920"/>
          </a:xfrm>
          <a:custGeom>
            <a:avLst/>
            <a:gdLst>
              <a:gd name="textAreaLeft" fmla="*/ 0 w 1666800"/>
              <a:gd name="textAreaRight" fmla="*/ 1667160 w 1666800"/>
              <a:gd name="textAreaTop" fmla="*/ 0 h 1501920"/>
              <a:gd name="textAreaBottom" fmla="*/ 1502280 h 1501920"/>
            </a:gdLst>
            <a:ahLst/>
            <a:rect l="textAreaLeft" t="textAreaTop" r="textAreaRight" b="textAreaBottom"/>
            <a:pathLst>
              <a:path w="1716" h="1778">
                <a:moveTo>
                  <a:pt x="1716" y="1033"/>
                </a:moveTo>
                <a:lnTo>
                  <a:pt x="1716" y="1778"/>
                </a:lnTo>
                <a:moveTo>
                  <a:pt x="1338" y="1033"/>
                </a:moveTo>
                <a:lnTo>
                  <a:pt x="1716" y="1033"/>
                </a:lnTo>
                <a:moveTo>
                  <a:pt x="1338" y="787"/>
                </a:moveTo>
                <a:lnTo>
                  <a:pt x="1338" y="1033"/>
                </a:lnTo>
                <a:moveTo>
                  <a:pt x="1152" y="787"/>
                </a:moveTo>
                <a:lnTo>
                  <a:pt x="1338" y="787"/>
                </a:lnTo>
                <a:moveTo>
                  <a:pt x="1152" y="589"/>
                </a:moveTo>
                <a:lnTo>
                  <a:pt x="1152" y="787"/>
                </a:lnTo>
                <a:moveTo>
                  <a:pt x="684" y="589"/>
                </a:moveTo>
                <a:lnTo>
                  <a:pt x="1152" y="589"/>
                </a:lnTo>
                <a:moveTo>
                  <a:pt x="684" y="390"/>
                </a:moveTo>
                <a:lnTo>
                  <a:pt x="684" y="589"/>
                </a:lnTo>
                <a:moveTo>
                  <a:pt x="510" y="390"/>
                </a:moveTo>
                <a:lnTo>
                  <a:pt x="684" y="390"/>
                </a:lnTo>
                <a:moveTo>
                  <a:pt x="510" y="252"/>
                </a:moveTo>
                <a:lnTo>
                  <a:pt x="510" y="390"/>
                </a:lnTo>
                <a:moveTo>
                  <a:pt x="366" y="252"/>
                </a:moveTo>
                <a:lnTo>
                  <a:pt x="510" y="252"/>
                </a:lnTo>
                <a:moveTo>
                  <a:pt x="366" y="126"/>
                </a:moveTo>
                <a:lnTo>
                  <a:pt x="366" y="252"/>
                </a:lnTo>
                <a:moveTo>
                  <a:pt x="66" y="126"/>
                </a:moveTo>
                <a:lnTo>
                  <a:pt x="366" y="126"/>
                </a:lnTo>
                <a:moveTo>
                  <a:pt x="66" y="0"/>
                </a:moveTo>
                <a:lnTo>
                  <a:pt x="66" y="126"/>
                </a:lnTo>
                <a:moveTo>
                  <a:pt x="0" y="0"/>
                </a:moveTo>
                <a:lnTo>
                  <a:pt x="6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10"/>
          <p:cNvSpPr/>
          <p:nvPr/>
        </p:nvSpPr>
        <p:spPr>
          <a:xfrm>
            <a:off x="1220760" y="6299280"/>
            <a:ext cx="1959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11"/>
          <p:cNvSpPr/>
          <p:nvPr/>
        </p:nvSpPr>
        <p:spPr>
          <a:xfrm flipV="1">
            <a:off x="1220760" y="4797360"/>
            <a:ext cx="0" cy="1501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正方形/長方形 606"/>
          <p:cNvSpPr/>
          <p:nvPr/>
        </p:nvSpPr>
        <p:spPr>
          <a:xfrm>
            <a:off x="1352520" y="4691160"/>
            <a:ext cx="18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+) (n=1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正方形/長方形 606"/>
          <p:cNvSpPr/>
          <p:nvPr/>
        </p:nvSpPr>
        <p:spPr>
          <a:xfrm>
            <a:off x="1216080" y="5502240"/>
            <a:ext cx="181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-) (n=1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608"/>
          <p:cNvSpPr/>
          <p:nvPr/>
        </p:nvSpPr>
        <p:spPr>
          <a:xfrm>
            <a:off x="1962360" y="488628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525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05"/>
          <p:cNvSpPr/>
          <p:nvPr/>
        </p:nvSpPr>
        <p:spPr>
          <a:xfrm>
            <a:off x="4496040" y="1457280"/>
            <a:ext cx="60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24"/>
          <p:cNvSpPr/>
          <p:nvPr/>
        </p:nvSpPr>
        <p:spPr>
          <a:xfrm>
            <a:off x="4313160" y="3759120"/>
            <a:ext cx="1151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25"/>
          <p:cNvSpPr/>
          <p:nvPr/>
        </p:nvSpPr>
        <p:spPr>
          <a:xfrm>
            <a:off x="585432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26"/>
          <p:cNvSpPr/>
          <p:nvPr/>
        </p:nvSpPr>
        <p:spPr>
          <a:xfrm>
            <a:off x="552240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27"/>
          <p:cNvSpPr/>
          <p:nvPr/>
        </p:nvSpPr>
        <p:spPr>
          <a:xfrm>
            <a:off x="519552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28"/>
          <p:cNvSpPr/>
          <p:nvPr/>
        </p:nvSpPr>
        <p:spPr>
          <a:xfrm>
            <a:off x="486540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29"/>
          <p:cNvSpPr/>
          <p:nvPr/>
        </p:nvSpPr>
        <p:spPr>
          <a:xfrm>
            <a:off x="453528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30"/>
          <p:cNvSpPr/>
          <p:nvPr/>
        </p:nvSpPr>
        <p:spPr>
          <a:xfrm>
            <a:off x="420660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31"/>
          <p:cNvSpPr/>
          <p:nvPr/>
        </p:nvSpPr>
        <p:spPr>
          <a:xfrm>
            <a:off x="3835080" y="3605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132"/>
          <p:cNvSpPr/>
          <p:nvPr/>
        </p:nvSpPr>
        <p:spPr>
          <a:xfrm rot="16200000">
            <a:off x="3033000" y="275364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33"/>
          <p:cNvSpPr/>
          <p:nvPr/>
        </p:nvSpPr>
        <p:spPr>
          <a:xfrm>
            <a:off x="3680640" y="1982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34"/>
          <p:cNvSpPr/>
          <p:nvPr/>
        </p:nvSpPr>
        <p:spPr>
          <a:xfrm>
            <a:off x="3744720" y="22971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135"/>
          <p:cNvSpPr/>
          <p:nvPr/>
        </p:nvSpPr>
        <p:spPr>
          <a:xfrm>
            <a:off x="3744720" y="26067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136"/>
          <p:cNvSpPr/>
          <p:nvPr/>
        </p:nvSpPr>
        <p:spPr>
          <a:xfrm>
            <a:off x="3744720" y="29163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37"/>
          <p:cNvSpPr/>
          <p:nvPr/>
        </p:nvSpPr>
        <p:spPr>
          <a:xfrm>
            <a:off x="3744720" y="32036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147"/>
          <p:cNvSpPr/>
          <p:nvPr/>
        </p:nvSpPr>
        <p:spPr>
          <a:xfrm>
            <a:off x="3900600" y="3573360"/>
            <a:ext cx="1977840" cy="11160"/>
          </a:xfrm>
          <a:custGeom>
            <a:avLst/>
            <a:gdLst>
              <a:gd name="textAreaLeft" fmla="*/ 0 w 1977840"/>
              <a:gd name="textAreaRight" fmla="*/ 1978200 w 197784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2016" h="12">
                <a:moveTo>
                  <a:pt x="2016" y="0"/>
                </a:moveTo>
                <a:lnTo>
                  <a:pt x="2016" y="12"/>
                </a:lnTo>
                <a:moveTo>
                  <a:pt x="1680" y="0"/>
                </a:moveTo>
                <a:lnTo>
                  <a:pt x="1680" y="12"/>
                </a:lnTo>
                <a:moveTo>
                  <a:pt x="1344" y="0"/>
                </a:moveTo>
                <a:lnTo>
                  <a:pt x="1344" y="12"/>
                </a:lnTo>
                <a:moveTo>
                  <a:pt x="1008" y="0"/>
                </a:moveTo>
                <a:lnTo>
                  <a:pt x="1008" y="12"/>
                </a:lnTo>
                <a:moveTo>
                  <a:pt x="672" y="0"/>
                </a:moveTo>
                <a:lnTo>
                  <a:pt x="672" y="12"/>
                </a:lnTo>
                <a:moveTo>
                  <a:pt x="336" y="0"/>
                </a:moveTo>
                <a:lnTo>
                  <a:pt x="336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148"/>
          <p:cNvSpPr/>
          <p:nvPr/>
        </p:nvSpPr>
        <p:spPr>
          <a:xfrm>
            <a:off x="3884760" y="2052720"/>
            <a:ext cx="15840" cy="1517400"/>
          </a:xfrm>
          <a:custGeom>
            <a:avLst/>
            <a:gdLst>
              <a:gd name="textAreaLeft" fmla="*/ 0 w 15840"/>
              <a:gd name="textAreaRight" fmla="*/ 16200 w 15840"/>
              <a:gd name="textAreaTop" fmla="*/ 0 h 1517400"/>
              <a:gd name="textAreaBottom" fmla="*/ 1517760 h 151740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149"/>
          <p:cNvSpPr/>
          <p:nvPr/>
        </p:nvSpPr>
        <p:spPr>
          <a:xfrm>
            <a:off x="3963960" y="2052720"/>
            <a:ext cx="1717560" cy="441360"/>
          </a:xfrm>
          <a:custGeom>
            <a:avLst/>
            <a:gdLst>
              <a:gd name="textAreaLeft" fmla="*/ 0 w 1717560"/>
              <a:gd name="textAreaRight" fmla="*/ 1717920 w 1717560"/>
              <a:gd name="textAreaTop" fmla="*/ 0 h 441360"/>
              <a:gd name="textAreaBottom" fmla="*/ 441720 h 441360"/>
            </a:gdLst>
            <a:ahLst/>
            <a:rect l="textAreaLeft" t="textAreaTop" r="textAreaRight" b="textAreaBottom"/>
            <a:pathLst>
              <a:path w="1752" h="517">
                <a:moveTo>
                  <a:pt x="1140" y="517"/>
                </a:moveTo>
                <a:lnTo>
                  <a:pt x="1752" y="517"/>
                </a:lnTo>
                <a:moveTo>
                  <a:pt x="1140" y="312"/>
                </a:moveTo>
                <a:lnTo>
                  <a:pt x="1140" y="517"/>
                </a:lnTo>
                <a:moveTo>
                  <a:pt x="582" y="312"/>
                </a:moveTo>
                <a:lnTo>
                  <a:pt x="1140" y="312"/>
                </a:lnTo>
                <a:moveTo>
                  <a:pt x="582" y="222"/>
                </a:moveTo>
                <a:lnTo>
                  <a:pt x="582" y="312"/>
                </a:lnTo>
                <a:moveTo>
                  <a:pt x="534" y="222"/>
                </a:moveTo>
                <a:lnTo>
                  <a:pt x="582" y="222"/>
                </a:lnTo>
                <a:moveTo>
                  <a:pt x="534" y="138"/>
                </a:moveTo>
                <a:lnTo>
                  <a:pt x="534" y="222"/>
                </a:lnTo>
                <a:moveTo>
                  <a:pt x="198" y="138"/>
                </a:moveTo>
                <a:lnTo>
                  <a:pt x="534" y="138"/>
                </a:lnTo>
                <a:moveTo>
                  <a:pt x="198" y="66"/>
                </a:moveTo>
                <a:lnTo>
                  <a:pt x="198" y="138"/>
                </a:lnTo>
                <a:moveTo>
                  <a:pt x="0" y="66"/>
                </a:moveTo>
                <a:lnTo>
                  <a:pt x="198" y="66"/>
                </a:lnTo>
                <a:moveTo>
                  <a:pt x="0" y="0"/>
                </a:moveTo>
                <a:lnTo>
                  <a:pt x="0" y="66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150"/>
          <p:cNvSpPr/>
          <p:nvPr/>
        </p:nvSpPr>
        <p:spPr>
          <a:xfrm>
            <a:off x="3963960" y="2052720"/>
            <a:ext cx="1717560" cy="137880"/>
          </a:xfrm>
          <a:custGeom>
            <a:avLst/>
            <a:gdLst>
              <a:gd name="textAreaLeft" fmla="*/ 0 w 1717560"/>
              <a:gd name="textAreaRight" fmla="*/ 1717920 w 1717560"/>
              <a:gd name="textAreaTop" fmla="*/ 0 h 137880"/>
              <a:gd name="textAreaBottom" fmla="*/ 138240 h 137880"/>
            </a:gdLst>
            <a:ahLst/>
            <a:rect l="textAreaLeft" t="textAreaTop" r="textAreaRight" b="textAreaBottom"/>
            <a:pathLst>
              <a:path w="1752" h="162">
                <a:moveTo>
                  <a:pt x="1416" y="162"/>
                </a:moveTo>
                <a:lnTo>
                  <a:pt x="1752" y="162"/>
                </a:lnTo>
                <a:moveTo>
                  <a:pt x="1416" y="0"/>
                </a:moveTo>
                <a:lnTo>
                  <a:pt x="1416" y="162"/>
                </a:lnTo>
                <a:moveTo>
                  <a:pt x="0" y="0"/>
                </a:moveTo>
                <a:lnTo>
                  <a:pt x="141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153"/>
          <p:cNvSpPr/>
          <p:nvPr/>
        </p:nvSpPr>
        <p:spPr>
          <a:xfrm>
            <a:off x="3900600" y="3570120"/>
            <a:ext cx="1977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54"/>
          <p:cNvSpPr/>
          <p:nvPr/>
        </p:nvSpPr>
        <p:spPr>
          <a:xfrm flipV="1">
            <a:off x="3900600" y="2052360"/>
            <a:ext cx="1440" cy="151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正方形/長方形 606"/>
          <p:cNvSpPr/>
          <p:nvPr/>
        </p:nvSpPr>
        <p:spPr>
          <a:xfrm>
            <a:off x="3987720" y="1822320"/>
            <a:ext cx="181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(-) (n=33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正方形/長方形 606"/>
          <p:cNvSpPr/>
          <p:nvPr/>
        </p:nvSpPr>
        <p:spPr>
          <a:xfrm>
            <a:off x="3963960" y="2525760"/>
            <a:ext cx="181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(+) (n=2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正方形/長方形 608"/>
          <p:cNvSpPr/>
          <p:nvPr/>
        </p:nvSpPr>
        <p:spPr>
          <a:xfrm>
            <a:off x="4535640" y="210024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6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98"/>
          <p:cNvSpPr/>
          <p:nvPr/>
        </p:nvSpPr>
        <p:spPr>
          <a:xfrm>
            <a:off x="4400640" y="6469200"/>
            <a:ext cx="1151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99"/>
          <p:cNvSpPr/>
          <p:nvPr/>
        </p:nvSpPr>
        <p:spPr>
          <a:xfrm>
            <a:off x="595908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00"/>
          <p:cNvSpPr/>
          <p:nvPr/>
        </p:nvSpPr>
        <p:spPr>
          <a:xfrm>
            <a:off x="562104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01"/>
          <p:cNvSpPr/>
          <p:nvPr/>
        </p:nvSpPr>
        <p:spPr>
          <a:xfrm>
            <a:off x="527796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02"/>
          <p:cNvSpPr/>
          <p:nvPr/>
        </p:nvSpPr>
        <p:spPr>
          <a:xfrm>
            <a:off x="493848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03"/>
          <p:cNvSpPr/>
          <p:nvPr/>
        </p:nvSpPr>
        <p:spPr>
          <a:xfrm>
            <a:off x="459864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204"/>
          <p:cNvSpPr/>
          <p:nvPr/>
        </p:nvSpPr>
        <p:spPr>
          <a:xfrm>
            <a:off x="425556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205"/>
          <p:cNvSpPr/>
          <p:nvPr/>
        </p:nvSpPr>
        <p:spPr>
          <a:xfrm>
            <a:off x="3876480" y="6318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06"/>
          <p:cNvSpPr/>
          <p:nvPr/>
        </p:nvSpPr>
        <p:spPr>
          <a:xfrm rot="16200000">
            <a:off x="3091680" y="543024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207"/>
          <p:cNvSpPr/>
          <p:nvPr/>
        </p:nvSpPr>
        <p:spPr>
          <a:xfrm>
            <a:off x="3750480" y="47102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208"/>
          <p:cNvSpPr/>
          <p:nvPr/>
        </p:nvSpPr>
        <p:spPr>
          <a:xfrm>
            <a:off x="3803400" y="50007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209"/>
          <p:cNvSpPr/>
          <p:nvPr/>
        </p:nvSpPr>
        <p:spPr>
          <a:xfrm>
            <a:off x="3803400" y="52783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210"/>
          <p:cNvSpPr/>
          <p:nvPr/>
        </p:nvSpPr>
        <p:spPr>
          <a:xfrm>
            <a:off x="3803400" y="560088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211"/>
          <p:cNvSpPr/>
          <p:nvPr/>
        </p:nvSpPr>
        <p:spPr>
          <a:xfrm>
            <a:off x="3803400" y="58910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221"/>
          <p:cNvSpPr/>
          <p:nvPr/>
        </p:nvSpPr>
        <p:spPr>
          <a:xfrm>
            <a:off x="3940200" y="6288120"/>
            <a:ext cx="2044800" cy="9360"/>
          </a:xfrm>
          <a:custGeom>
            <a:avLst/>
            <a:gdLst>
              <a:gd name="textAreaLeft" fmla="*/ 0 w 2044800"/>
              <a:gd name="textAreaRight" fmla="*/ 2045160 w 204480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2064" h="12">
                <a:moveTo>
                  <a:pt x="2064" y="0"/>
                </a:moveTo>
                <a:lnTo>
                  <a:pt x="2064" y="12"/>
                </a:lnTo>
                <a:moveTo>
                  <a:pt x="1722" y="0"/>
                </a:moveTo>
                <a:lnTo>
                  <a:pt x="1722" y="12"/>
                </a:lnTo>
                <a:moveTo>
                  <a:pt x="1374" y="0"/>
                </a:moveTo>
                <a:lnTo>
                  <a:pt x="1374" y="12"/>
                </a:lnTo>
                <a:moveTo>
                  <a:pt x="1032" y="0"/>
                </a:moveTo>
                <a:lnTo>
                  <a:pt x="1032" y="12"/>
                </a:lnTo>
                <a:moveTo>
                  <a:pt x="690" y="0"/>
                </a:moveTo>
                <a:lnTo>
                  <a:pt x="690" y="12"/>
                </a:lnTo>
                <a:moveTo>
                  <a:pt x="342" y="0"/>
                </a:moveTo>
                <a:lnTo>
                  <a:pt x="342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222"/>
          <p:cNvSpPr/>
          <p:nvPr/>
        </p:nvSpPr>
        <p:spPr>
          <a:xfrm>
            <a:off x="3922560" y="4768920"/>
            <a:ext cx="17640" cy="1514520"/>
          </a:xfrm>
          <a:custGeom>
            <a:avLst/>
            <a:gdLst>
              <a:gd name="textAreaLeft" fmla="*/ 0 w 17640"/>
              <a:gd name="textAreaRight" fmla="*/ 18000 w 17640"/>
              <a:gd name="textAreaTop" fmla="*/ 0 h 1514520"/>
              <a:gd name="textAreaBottom" fmla="*/ 1514880 h 151452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223"/>
          <p:cNvSpPr/>
          <p:nvPr/>
        </p:nvSpPr>
        <p:spPr>
          <a:xfrm>
            <a:off x="3973680" y="4768920"/>
            <a:ext cx="1734840" cy="1514520"/>
          </a:xfrm>
          <a:custGeom>
            <a:avLst/>
            <a:gdLst>
              <a:gd name="textAreaLeft" fmla="*/ 0 w 1734840"/>
              <a:gd name="textAreaRight" fmla="*/ 1735200 w 1734840"/>
              <a:gd name="textAreaTop" fmla="*/ 0 h 1514520"/>
              <a:gd name="textAreaBottom" fmla="*/ 1514880 h 1514520"/>
            </a:gdLst>
            <a:ahLst/>
            <a:rect l="textAreaLeft" t="textAreaTop" r="textAreaRight" b="textAreaBottom"/>
            <a:pathLst>
              <a:path w="1752" h="1778">
                <a:moveTo>
                  <a:pt x="1752" y="1273"/>
                </a:moveTo>
                <a:lnTo>
                  <a:pt x="1752" y="1778"/>
                </a:lnTo>
                <a:moveTo>
                  <a:pt x="1362" y="1273"/>
                </a:moveTo>
                <a:lnTo>
                  <a:pt x="1752" y="1273"/>
                </a:lnTo>
                <a:moveTo>
                  <a:pt x="1362" y="1015"/>
                </a:moveTo>
                <a:lnTo>
                  <a:pt x="1362" y="1273"/>
                </a:lnTo>
                <a:moveTo>
                  <a:pt x="1284" y="1015"/>
                </a:moveTo>
                <a:lnTo>
                  <a:pt x="1362" y="1015"/>
                </a:lnTo>
                <a:moveTo>
                  <a:pt x="1284" y="763"/>
                </a:moveTo>
                <a:lnTo>
                  <a:pt x="1284" y="1015"/>
                </a:lnTo>
                <a:moveTo>
                  <a:pt x="1182" y="763"/>
                </a:moveTo>
                <a:lnTo>
                  <a:pt x="1284" y="763"/>
                </a:lnTo>
                <a:moveTo>
                  <a:pt x="1182" y="559"/>
                </a:moveTo>
                <a:lnTo>
                  <a:pt x="1182" y="763"/>
                </a:lnTo>
                <a:moveTo>
                  <a:pt x="516" y="559"/>
                </a:moveTo>
                <a:lnTo>
                  <a:pt x="1182" y="559"/>
                </a:lnTo>
                <a:moveTo>
                  <a:pt x="516" y="438"/>
                </a:moveTo>
                <a:lnTo>
                  <a:pt x="516" y="559"/>
                </a:lnTo>
                <a:moveTo>
                  <a:pt x="372" y="438"/>
                </a:moveTo>
                <a:lnTo>
                  <a:pt x="516" y="438"/>
                </a:lnTo>
                <a:moveTo>
                  <a:pt x="372" y="330"/>
                </a:moveTo>
                <a:lnTo>
                  <a:pt x="372" y="438"/>
                </a:lnTo>
                <a:moveTo>
                  <a:pt x="114" y="330"/>
                </a:moveTo>
                <a:lnTo>
                  <a:pt x="372" y="330"/>
                </a:lnTo>
                <a:moveTo>
                  <a:pt x="114" y="216"/>
                </a:moveTo>
                <a:lnTo>
                  <a:pt x="114" y="330"/>
                </a:lnTo>
                <a:moveTo>
                  <a:pt x="66" y="216"/>
                </a:moveTo>
                <a:lnTo>
                  <a:pt x="114" y="216"/>
                </a:lnTo>
                <a:moveTo>
                  <a:pt x="66" y="102"/>
                </a:moveTo>
                <a:lnTo>
                  <a:pt x="66" y="216"/>
                </a:lnTo>
                <a:moveTo>
                  <a:pt x="0" y="102"/>
                </a:moveTo>
                <a:lnTo>
                  <a:pt x="66" y="102"/>
                </a:lnTo>
                <a:moveTo>
                  <a:pt x="0" y="0"/>
                </a:moveTo>
                <a:lnTo>
                  <a:pt x="0" y="102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224"/>
          <p:cNvSpPr/>
          <p:nvPr/>
        </p:nvSpPr>
        <p:spPr>
          <a:xfrm>
            <a:off x="3973680" y="4768920"/>
            <a:ext cx="1930320" cy="301680"/>
          </a:xfrm>
          <a:custGeom>
            <a:avLst/>
            <a:gdLst>
              <a:gd name="textAreaLeft" fmla="*/ 0 w 1930320"/>
              <a:gd name="textAreaRight" fmla="*/ 1930680 w 1930320"/>
              <a:gd name="textAreaTop" fmla="*/ 0 h 301680"/>
              <a:gd name="textAreaBottom" fmla="*/ 302040 h 301680"/>
            </a:gdLst>
            <a:ahLst/>
            <a:rect l="textAreaLeft" t="textAreaTop" r="textAreaRight" b="textAreaBottom"/>
            <a:pathLst>
              <a:path w="1950" h="354">
                <a:moveTo>
                  <a:pt x="1950" y="354"/>
                </a:moveTo>
                <a:lnTo>
                  <a:pt x="1950" y="354"/>
                </a:lnTo>
                <a:moveTo>
                  <a:pt x="696" y="354"/>
                </a:moveTo>
                <a:lnTo>
                  <a:pt x="1950" y="354"/>
                </a:lnTo>
                <a:moveTo>
                  <a:pt x="696" y="0"/>
                </a:moveTo>
                <a:lnTo>
                  <a:pt x="696" y="354"/>
                </a:lnTo>
                <a:moveTo>
                  <a:pt x="0" y="0"/>
                </a:moveTo>
                <a:lnTo>
                  <a:pt x="69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227"/>
          <p:cNvSpPr/>
          <p:nvPr/>
        </p:nvSpPr>
        <p:spPr>
          <a:xfrm>
            <a:off x="3940200" y="6283440"/>
            <a:ext cx="2044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228"/>
          <p:cNvSpPr/>
          <p:nvPr/>
        </p:nvSpPr>
        <p:spPr>
          <a:xfrm flipV="1">
            <a:off x="3940200" y="4768560"/>
            <a:ext cx="1440" cy="1514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正方形/長方形 606"/>
          <p:cNvSpPr/>
          <p:nvPr/>
        </p:nvSpPr>
        <p:spPr>
          <a:xfrm>
            <a:off x="4500720" y="4765680"/>
            <a:ext cx="12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(-) (n=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正方形/長方形 606"/>
          <p:cNvSpPr/>
          <p:nvPr/>
        </p:nvSpPr>
        <p:spPr>
          <a:xfrm>
            <a:off x="3770280" y="5305320"/>
            <a:ext cx="181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(+) (n=1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正方形/長方形 608"/>
          <p:cNvSpPr/>
          <p:nvPr/>
        </p:nvSpPr>
        <p:spPr>
          <a:xfrm>
            <a:off x="4632480" y="502776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5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4"/>
          <p:cNvSpPr/>
          <p:nvPr/>
        </p:nvSpPr>
        <p:spPr>
          <a:xfrm>
            <a:off x="1506240" y="4330800"/>
            <a:ext cx="1227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-cadher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5"/>
          <p:cNvSpPr/>
          <p:nvPr/>
        </p:nvSpPr>
        <p:spPr>
          <a:xfrm>
            <a:off x="4496040" y="4330800"/>
            <a:ext cx="60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6"/>
          <p:cNvSpPr/>
          <p:nvPr/>
        </p:nvSpPr>
        <p:spPr>
          <a:xfrm>
            <a:off x="6572160" y="1486080"/>
            <a:ext cx="19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-cadherin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232"/>
          <p:cNvSpPr/>
          <p:nvPr/>
        </p:nvSpPr>
        <p:spPr>
          <a:xfrm>
            <a:off x="7034040" y="3770280"/>
            <a:ext cx="1151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233"/>
          <p:cNvSpPr/>
          <p:nvPr/>
        </p:nvSpPr>
        <p:spPr>
          <a:xfrm>
            <a:off x="862308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234"/>
          <p:cNvSpPr/>
          <p:nvPr/>
        </p:nvSpPr>
        <p:spPr>
          <a:xfrm>
            <a:off x="827676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235"/>
          <p:cNvSpPr/>
          <p:nvPr/>
        </p:nvSpPr>
        <p:spPr>
          <a:xfrm>
            <a:off x="792432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236"/>
          <p:cNvSpPr/>
          <p:nvPr/>
        </p:nvSpPr>
        <p:spPr>
          <a:xfrm>
            <a:off x="757692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237"/>
          <p:cNvSpPr/>
          <p:nvPr/>
        </p:nvSpPr>
        <p:spPr>
          <a:xfrm>
            <a:off x="723240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238"/>
          <p:cNvSpPr/>
          <p:nvPr/>
        </p:nvSpPr>
        <p:spPr>
          <a:xfrm>
            <a:off x="688140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239"/>
          <p:cNvSpPr/>
          <p:nvPr/>
        </p:nvSpPr>
        <p:spPr>
          <a:xfrm>
            <a:off x="6482880" y="358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240"/>
          <p:cNvSpPr/>
          <p:nvPr/>
        </p:nvSpPr>
        <p:spPr>
          <a:xfrm rot="16200000">
            <a:off x="5718960" y="273384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241"/>
          <p:cNvSpPr/>
          <p:nvPr/>
        </p:nvSpPr>
        <p:spPr>
          <a:xfrm>
            <a:off x="6357240" y="1955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242"/>
          <p:cNvSpPr/>
          <p:nvPr/>
        </p:nvSpPr>
        <p:spPr>
          <a:xfrm>
            <a:off x="6427440" y="22669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243"/>
          <p:cNvSpPr/>
          <p:nvPr/>
        </p:nvSpPr>
        <p:spPr>
          <a:xfrm>
            <a:off x="6427440" y="257328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244"/>
          <p:cNvSpPr/>
          <p:nvPr/>
        </p:nvSpPr>
        <p:spPr>
          <a:xfrm>
            <a:off x="6427440" y="285120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45"/>
          <p:cNvSpPr/>
          <p:nvPr/>
        </p:nvSpPr>
        <p:spPr>
          <a:xfrm>
            <a:off x="6427440" y="31640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253"/>
          <p:cNvSpPr/>
          <p:nvPr/>
        </p:nvSpPr>
        <p:spPr>
          <a:xfrm>
            <a:off x="6558120" y="3552840"/>
            <a:ext cx="2087280" cy="9360"/>
          </a:xfrm>
          <a:custGeom>
            <a:avLst/>
            <a:gdLst>
              <a:gd name="textAreaLeft" fmla="*/ 0 w 2087280"/>
              <a:gd name="textAreaRight" fmla="*/ 2087640 w 208728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368" h="2">
                <a:moveTo>
                  <a:pt x="368" y="0"/>
                </a:moveTo>
                <a:lnTo>
                  <a:pt x="368" y="2"/>
                </a:lnTo>
                <a:moveTo>
                  <a:pt x="307" y="0"/>
                </a:moveTo>
                <a:lnTo>
                  <a:pt x="307" y="2"/>
                </a:lnTo>
                <a:moveTo>
                  <a:pt x="245" y="0"/>
                </a:moveTo>
                <a:lnTo>
                  <a:pt x="245" y="2"/>
                </a:lnTo>
                <a:moveTo>
                  <a:pt x="184" y="0"/>
                </a:moveTo>
                <a:lnTo>
                  <a:pt x="184" y="2"/>
                </a:lnTo>
                <a:moveTo>
                  <a:pt x="123" y="0"/>
                </a:moveTo>
                <a:lnTo>
                  <a:pt x="123" y="2"/>
                </a:lnTo>
                <a:moveTo>
                  <a:pt x="61" y="0"/>
                </a:moveTo>
                <a:lnTo>
                  <a:pt x="61" y="2"/>
                </a:lnTo>
                <a:moveTo>
                  <a:pt x="0" y="0"/>
                </a:moveTo>
                <a:lnTo>
                  <a:pt x="0" y="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254"/>
          <p:cNvSpPr/>
          <p:nvPr/>
        </p:nvSpPr>
        <p:spPr>
          <a:xfrm>
            <a:off x="6540480" y="2021040"/>
            <a:ext cx="17640" cy="1525320"/>
          </a:xfrm>
          <a:custGeom>
            <a:avLst/>
            <a:gdLst>
              <a:gd name="textAreaLeft" fmla="*/ 0 w 17640"/>
              <a:gd name="textAreaRight" fmla="*/ 18000 w 17640"/>
              <a:gd name="textAreaTop" fmla="*/ 0 h 1525320"/>
              <a:gd name="textAreaBottom" fmla="*/ 1525680 h 1525320"/>
            </a:gdLst>
            <a:ahLst/>
            <a:rect l="textAreaLeft" t="textAreaTop" r="textAreaRight" b="textAreaBottom"/>
            <a:pathLst>
              <a:path w="3" h="296">
                <a:moveTo>
                  <a:pt x="0" y="0"/>
                </a:moveTo>
                <a:lnTo>
                  <a:pt x="3" y="0"/>
                </a:lnTo>
                <a:moveTo>
                  <a:pt x="0" y="59"/>
                </a:moveTo>
                <a:lnTo>
                  <a:pt x="3" y="59"/>
                </a:lnTo>
                <a:moveTo>
                  <a:pt x="0" y="118"/>
                </a:moveTo>
                <a:lnTo>
                  <a:pt x="3" y="118"/>
                </a:lnTo>
                <a:moveTo>
                  <a:pt x="0" y="178"/>
                </a:moveTo>
                <a:lnTo>
                  <a:pt x="3" y="178"/>
                </a:lnTo>
                <a:moveTo>
                  <a:pt x="0" y="237"/>
                </a:moveTo>
                <a:lnTo>
                  <a:pt x="3" y="237"/>
                </a:lnTo>
                <a:moveTo>
                  <a:pt x="0" y="296"/>
                </a:moveTo>
                <a:lnTo>
                  <a:pt x="3" y="296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255"/>
          <p:cNvSpPr/>
          <p:nvPr/>
        </p:nvSpPr>
        <p:spPr>
          <a:xfrm>
            <a:off x="6613560" y="2021040"/>
            <a:ext cx="1803240" cy="457200"/>
          </a:xfrm>
          <a:custGeom>
            <a:avLst/>
            <a:gdLst>
              <a:gd name="textAreaLeft" fmla="*/ 0 w 1803240"/>
              <a:gd name="textAreaRight" fmla="*/ 1803600 w 1803240"/>
              <a:gd name="textAreaTop" fmla="*/ 0 h 457200"/>
              <a:gd name="textAreaBottom" fmla="*/ 457560 h 457200"/>
            </a:gdLst>
            <a:ahLst/>
            <a:rect l="textAreaLeft" t="textAreaTop" r="textAreaRight" b="textAreaBottom"/>
            <a:pathLst>
              <a:path w="318" h="89">
                <a:moveTo>
                  <a:pt x="106" y="89"/>
                </a:moveTo>
                <a:lnTo>
                  <a:pt x="318" y="89"/>
                </a:lnTo>
                <a:moveTo>
                  <a:pt x="106" y="63"/>
                </a:moveTo>
                <a:lnTo>
                  <a:pt x="106" y="89"/>
                </a:lnTo>
                <a:moveTo>
                  <a:pt x="98" y="63"/>
                </a:moveTo>
                <a:lnTo>
                  <a:pt x="106" y="63"/>
                </a:lnTo>
                <a:moveTo>
                  <a:pt x="98" y="37"/>
                </a:moveTo>
                <a:lnTo>
                  <a:pt x="98" y="63"/>
                </a:lnTo>
                <a:moveTo>
                  <a:pt x="35" y="37"/>
                </a:moveTo>
                <a:lnTo>
                  <a:pt x="98" y="37"/>
                </a:lnTo>
                <a:moveTo>
                  <a:pt x="35" y="18"/>
                </a:moveTo>
                <a:lnTo>
                  <a:pt x="35" y="37"/>
                </a:lnTo>
                <a:moveTo>
                  <a:pt x="0" y="18"/>
                </a:moveTo>
                <a:lnTo>
                  <a:pt x="35" y="18"/>
                </a:lnTo>
                <a:moveTo>
                  <a:pt x="0" y="0"/>
                </a:moveTo>
                <a:lnTo>
                  <a:pt x="0" y="18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256"/>
          <p:cNvSpPr/>
          <p:nvPr/>
        </p:nvSpPr>
        <p:spPr>
          <a:xfrm>
            <a:off x="6613560" y="2021040"/>
            <a:ext cx="1803240" cy="226800"/>
          </a:xfrm>
          <a:custGeom>
            <a:avLst/>
            <a:gdLst>
              <a:gd name="textAreaLeft" fmla="*/ 0 w 1803240"/>
              <a:gd name="textAreaRight" fmla="*/ 1803600 w 1803240"/>
              <a:gd name="textAreaTop" fmla="*/ 0 h 226800"/>
              <a:gd name="textAreaBottom" fmla="*/ 227160 h 226800"/>
            </a:gdLst>
            <a:ahLst/>
            <a:rect l="textAreaLeft" t="textAreaTop" r="textAreaRight" b="textAreaBottom"/>
            <a:pathLst>
              <a:path w="318" h="44">
                <a:moveTo>
                  <a:pt x="258" y="44"/>
                </a:moveTo>
                <a:lnTo>
                  <a:pt x="318" y="44"/>
                </a:lnTo>
                <a:moveTo>
                  <a:pt x="258" y="21"/>
                </a:moveTo>
                <a:lnTo>
                  <a:pt x="258" y="44"/>
                </a:lnTo>
                <a:moveTo>
                  <a:pt x="208" y="21"/>
                </a:moveTo>
                <a:lnTo>
                  <a:pt x="258" y="21"/>
                </a:lnTo>
                <a:moveTo>
                  <a:pt x="208" y="0"/>
                </a:moveTo>
                <a:lnTo>
                  <a:pt x="208" y="21"/>
                </a:lnTo>
                <a:moveTo>
                  <a:pt x="0" y="0"/>
                </a:moveTo>
                <a:lnTo>
                  <a:pt x="20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259"/>
          <p:cNvSpPr/>
          <p:nvPr/>
        </p:nvSpPr>
        <p:spPr>
          <a:xfrm>
            <a:off x="6558120" y="3546360"/>
            <a:ext cx="208728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260"/>
          <p:cNvSpPr/>
          <p:nvPr/>
        </p:nvSpPr>
        <p:spPr>
          <a:xfrm flipV="1">
            <a:off x="6558120" y="2020680"/>
            <a:ext cx="4680" cy="1525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正方形/長方形 606"/>
          <p:cNvSpPr/>
          <p:nvPr/>
        </p:nvSpPr>
        <p:spPr>
          <a:xfrm>
            <a:off x="6434280" y="1812960"/>
            <a:ext cx="23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+) or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 (-) (n=43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テキスト ボックス 604"/>
          <p:cNvSpPr/>
          <p:nvPr/>
        </p:nvSpPr>
        <p:spPr>
          <a:xfrm>
            <a:off x="6540480" y="2513160"/>
            <a:ext cx="235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-) and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 (+) (n=1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正方形/長方形 608"/>
          <p:cNvSpPr/>
          <p:nvPr/>
        </p:nvSpPr>
        <p:spPr>
          <a:xfrm>
            <a:off x="7251840" y="218592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04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304"/>
          <p:cNvSpPr/>
          <p:nvPr/>
        </p:nvSpPr>
        <p:spPr>
          <a:xfrm>
            <a:off x="7094520" y="6500880"/>
            <a:ext cx="1151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305"/>
          <p:cNvSpPr/>
          <p:nvPr/>
        </p:nvSpPr>
        <p:spPr>
          <a:xfrm>
            <a:off x="868320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306"/>
          <p:cNvSpPr/>
          <p:nvPr/>
        </p:nvSpPr>
        <p:spPr>
          <a:xfrm>
            <a:off x="833400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307"/>
          <p:cNvSpPr/>
          <p:nvPr/>
        </p:nvSpPr>
        <p:spPr>
          <a:xfrm>
            <a:off x="798804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308"/>
          <p:cNvSpPr/>
          <p:nvPr/>
        </p:nvSpPr>
        <p:spPr>
          <a:xfrm>
            <a:off x="763704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309"/>
          <p:cNvSpPr/>
          <p:nvPr/>
        </p:nvSpPr>
        <p:spPr>
          <a:xfrm>
            <a:off x="728784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310"/>
          <p:cNvSpPr/>
          <p:nvPr/>
        </p:nvSpPr>
        <p:spPr>
          <a:xfrm>
            <a:off x="694188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311"/>
          <p:cNvSpPr/>
          <p:nvPr/>
        </p:nvSpPr>
        <p:spPr>
          <a:xfrm>
            <a:off x="6560640" y="6313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312"/>
          <p:cNvSpPr/>
          <p:nvPr/>
        </p:nvSpPr>
        <p:spPr>
          <a:xfrm rot="16200000">
            <a:off x="5763600" y="5419800"/>
            <a:ext cx="120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313"/>
          <p:cNvSpPr/>
          <p:nvPr/>
        </p:nvSpPr>
        <p:spPr>
          <a:xfrm>
            <a:off x="6404760" y="46735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314"/>
          <p:cNvSpPr/>
          <p:nvPr/>
        </p:nvSpPr>
        <p:spPr>
          <a:xfrm>
            <a:off x="6481440" y="49784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315"/>
          <p:cNvSpPr/>
          <p:nvPr/>
        </p:nvSpPr>
        <p:spPr>
          <a:xfrm>
            <a:off x="6481440" y="528336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316"/>
          <p:cNvSpPr/>
          <p:nvPr/>
        </p:nvSpPr>
        <p:spPr>
          <a:xfrm>
            <a:off x="6481440" y="558792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317"/>
          <p:cNvSpPr/>
          <p:nvPr/>
        </p:nvSpPr>
        <p:spPr>
          <a:xfrm>
            <a:off x="6481440" y="5891040"/>
            <a:ext cx="1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327"/>
          <p:cNvSpPr/>
          <p:nvPr/>
        </p:nvSpPr>
        <p:spPr>
          <a:xfrm>
            <a:off x="6615000" y="6283440"/>
            <a:ext cx="2092320" cy="9360"/>
          </a:xfrm>
          <a:custGeom>
            <a:avLst/>
            <a:gdLst>
              <a:gd name="textAreaLeft" fmla="*/ 0 w 2092320"/>
              <a:gd name="textAreaRight" fmla="*/ 2092680 w 209232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2112" h="12">
                <a:moveTo>
                  <a:pt x="2112" y="0"/>
                </a:moveTo>
                <a:lnTo>
                  <a:pt x="2112" y="12"/>
                </a:lnTo>
                <a:moveTo>
                  <a:pt x="1758" y="0"/>
                </a:moveTo>
                <a:lnTo>
                  <a:pt x="1758" y="12"/>
                </a:lnTo>
                <a:moveTo>
                  <a:pt x="1410" y="0"/>
                </a:moveTo>
                <a:lnTo>
                  <a:pt x="1410" y="12"/>
                </a:lnTo>
                <a:moveTo>
                  <a:pt x="1056" y="0"/>
                </a:moveTo>
                <a:lnTo>
                  <a:pt x="1056" y="12"/>
                </a:lnTo>
                <a:moveTo>
                  <a:pt x="702" y="0"/>
                </a:moveTo>
                <a:lnTo>
                  <a:pt x="702" y="12"/>
                </a:lnTo>
                <a:moveTo>
                  <a:pt x="354" y="0"/>
                </a:moveTo>
                <a:lnTo>
                  <a:pt x="354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328"/>
          <p:cNvSpPr/>
          <p:nvPr/>
        </p:nvSpPr>
        <p:spPr>
          <a:xfrm>
            <a:off x="6597720" y="4745160"/>
            <a:ext cx="17280" cy="1531800"/>
          </a:xfrm>
          <a:custGeom>
            <a:avLst/>
            <a:gdLst>
              <a:gd name="textAreaLeft" fmla="*/ 0 w 17280"/>
              <a:gd name="textAreaRight" fmla="*/ 17640 w 17280"/>
              <a:gd name="textAreaTop" fmla="*/ 0 h 1531800"/>
              <a:gd name="textAreaBottom" fmla="*/ 1532160 h 153180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Freeform 329"/>
          <p:cNvSpPr/>
          <p:nvPr/>
        </p:nvSpPr>
        <p:spPr>
          <a:xfrm>
            <a:off x="6662880" y="4745160"/>
            <a:ext cx="1782720" cy="1531800"/>
          </a:xfrm>
          <a:custGeom>
            <a:avLst/>
            <a:gdLst>
              <a:gd name="textAreaLeft" fmla="*/ 0 w 1782720"/>
              <a:gd name="textAreaRight" fmla="*/ 1783080 w 1782720"/>
              <a:gd name="textAreaTop" fmla="*/ 0 h 1531800"/>
              <a:gd name="textAreaBottom" fmla="*/ 1532160 h 1531800"/>
            </a:gdLst>
            <a:ahLst/>
            <a:rect l="textAreaLeft" t="textAreaTop" r="textAreaRight" b="textAreaBottom"/>
            <a:pathLst>
              <a:path w="1800" h="1778">
                <a:moveTo>
                  <a:pt x="1800" y="1171"/>
                </a:moveTo>
                <a:lnTo>
                  <a:pt x="1800" y="1778"/>
                </a:lnTo>
                <a:moveTo>
                  <a:pt x="1398" y="1171"/>
                </a:moveTo>
                <a:lnTo>
                  <a:pt x="1800" y="1171"/>
                </a:lnTo>
                <a:moveTo>
                  <a:pt x="1398" y="865"/>
                </a:moveTo>
                <a:lnTo>
                  <a:pt x="1398" y="1171"/>
                </a:lnTo>
                <a:moveTo>
                  <a:pt x="1212" y="865"/>
                </a:moveTo>
                <a:lnTo>
                  <a:pt x="1398" y="865"/>
                </a:lnTo>
                <a:moveTo>
                  <a:pt x="1212" y="559"/>
                </a:moveTo>
                <a:lnTo>
                  <a:pt x="1212" y="865"/>
                </a:lnTo>
                <a:moveTo>
                  <a:pt x="534" y="559"/>
                </a:moveTo>
                <a:lnTo>
                  <a:pt x="1212" y="559"/>
                </a:lnTo>
                <a:moveTo>
                  <a:pt x="534" y="354"/>
                </a:moveTo>
                <a:lnTo>
                  <a:pt x="534" y="559"/>
                </a:lnTo>
                <a:moveTo>
                  <a:pt x="384" y="354"/>
                </a:moveTo>
                <a:lnTo>
                  <a:pt x="534" y="354"/>
                </a:lnTo>
                <a:moveTo>
                  <a:pt x="384" y="180"/>
                </a:moveTo>
                <a:lnTo>
                  <a:pt x="384" y="354"/>
                </a:lnTo>
                <a:moveTo>
                  <a:pt x="72" y="180"/>
                </a:moveTo>
                <a:lnTo>
                  <a:pt x="384" y="180"/>
                </a:lnTo>
                <a:moveTo>
                  <a:pt x="72" y="0"/>
                </a:moveTo>
                <a:lnTo>
                  <a:pt x="72" y="180"/>
                </a:lnTo>
                <a:moveTo>
                  <a:pt x="0" y="0"/>
                </a:moveTo>
                <a:lnTo>
                  <a:pt x="72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330"/>
          <p:cNvSpPr/>
          <p:nvPr/>
        </p:nvSpPr>
        <p:spPr>
          <a:xfrm>
            <a:off x="6662880" y="4745160"/>
            <a:ext cx="1979640" cy="677880"/>
          </a:xfrm>
          <a:custGeom>
            <a:avLst/>
            <a:gdLst>
              <a:gd name="textAreaLeft" fmla="*/ 0 w 1979640"/>
              <a:gd name="textAreaRight" fmla="*/ 1980000 w 1979640"/>
              <a:gd name="textAreaTop" fmla="*/ 0 h 677880"/>
              <a:gd name="textAreaBottom" fmla="*/ 678240 h 677880"/>
            </a:gdLst>
            <a:ahLst/>
            <a:rect l="textAreaLeft" t="textAreaTop" r="textAreaRight" b="textAreaBottom"/>
            <a:pathLst>
              <a:path w="1998" h="787">
                <a:moveTo>
                  <a:pt x="1998" y="787"/>
                </a:moveTo>
                <a:lnTo>
                  <a:pt x="1998" y="787"/>
                </a:lnTo>
                <a:moveTo>
                  <a:pt x="1320" y="787"/>
                </a:moveTo>
                <a:lnTo>
                  <a:pt x="1998" y="787"/>
                </a:lnTo>
                <a:moveTo>
                  <a:pt x="1320" y="456"/>
                </a:moveTo>
                <a:lnTo>
                  <a:pt x="1320" y="787"/>
                </a:lnTo>
                <a:moveTo>
                  <a:pt x="714" y="456"/>
                </a:moveTo>
                <a:lnTo>
                  <a:pt x="1320" y="456"/>
                </a:lnTo>
                <a:moveTo>
                  <a:pt x="714" y="264"/>
                </a:moveTo>
                <a:lnTo>
                  <a:pt x="714" y="456"/>
                </a:lnTo>
                <a:moveTo>
                  <a:pt x="120" y="264"/>
                </a:moveTo>
                <a:lnTo>
                  <a:pt x="714" y="264"/>
                </a:lnTo>
                <a:moveTo>
                  <a:pt x="120" y="126"/>
                </a:moveTo>
                <a:lnTo>
                  <a:pt x="120" y="264"/>
                </a:lnTo>
                <a:moveTo>
                  <a:pt x="0" y="126"/>
                </a:moveTo>
                <a:lnTo>
                  <a:pt x="120" y="126"/>
                </a:lnTo>
                <a:moveTo>
                  <a:pt x="0" y="0"/>
                </a:moveTo>
                <a:lnTo>
                  <a:pt x="0" y="126"/>
                </a:lnTo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333"/>
          <p:cNvSpPr/>
          <p:nvPr/>
        </p:nvSpPr>
        <p:spPr>
          <a:xfrm>
            <a:off x="6615000" y="6276960"/>
            <a:ext cx="2092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334"/>
          <p:cNvSpPr/>
          <p:nvPr/>
        </p:nvSpPr>
        <p:spPr>
          <a:xfrm flipV="1">
            <a:off x="6615000" y="4744800"/>
            <a:ext cx="1800" cy="153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正方形/長方形 606"/>
          <p:cNvSpPr/>
          <p:nvPr/>
        </p:nvSpPr>
        <p:spPr>
          <a:xfrm>
            <a:off x="6462720" y="4651200"/>
            <a:ext cx="2192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+) or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 (-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n=1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テキスト ボックス 604"/>
          <p:cNvSpPr/>
          <p:nvPr/>
        </p:nvSpPr>
        <p:spPr>
          <a:xfrm>
            <a:off x="6505560" y="5773680"/>
            <a:ext cx="1940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-cadherin (-) and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i67 (+) (n=1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正方形/長方形 608"/>
          <p:cNvSpPr/>
          <p:nvPr/>
        </p:nvSpPr>
        <p:spPr>
          <a:xfrm>
            <a:off x="7112160" y="5230800"/>
            <a:ext cx="71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=0.27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06"/>
          <p:cNvSpPr/>
          <p:nvPr/>
        </p:nvSpPr>
        <p:spPr>
          <a:xfrm>
            <a:off x="6597720" y="4344840"/>
            <a:ext cx="205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-cadherin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88920" y="652320"/>
            <a:ext cx="889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rvival of patients at stage I and III based on E-cadherin expression and Ki67 expressio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8T09:00:45Z</dcterms:created>
  <dc:creator>s.kashiwagi</dc:creator>
  <dc:description/>
  <dc:language>en-US</dc:language>
  <cp:lastModifiedBy>Yashiro</cp:lastModifiedBy>
  <cp:lastPrinted>2010-08-12T06:15:14Z</cp:lastPrinted>
  <dcterms:modified xsi:type="dcterms:W3CDTF">2011-11-26T14:56:42Z</dcterms:modified>
  <cp:revision>195</cp:revision>
  <dc:subject/>
  <dc:title>スライド 1</dc:title>
</cp:coreProperties>
</file>